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B53812-4361-4901-8CC8-17AB31EE1B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29DD6-7295-4020-9048-348FE88096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4FE48-22D5-47EA-90AC-8B0C0D64617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D709BD-8C39-4C54-9124-CE7BAFB4C9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742094-03E4-431D-AF00-9C3BD56652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0AE283-4883-42CD-A445-C142EEFAEC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7AF5C-9881-4AE4-A317-55C0452FBF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C661D8-AE44-46CF-B82C-B4354469A2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AE4954-CED3-4F53-98F8-231A2C4EDB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D60EBF-8158-480B-A8DA-1249746EFF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FB7EA-74FF-4946-9035-18C8565CAC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91A44-04BA-471B-A021-B517A00C69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C5628E-8FCF-44AE-A833-6C06101F1D3D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228240" y="228600"/>
            <a:ext cx="6248520" cy="129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) Location of implants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rontal brain sections stained for cresyl-violet were used to determine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sites of electrode placement. Electrode tracks, tissue scars and reference electrolytic lesions performed a few days before sacrifice were used to delimit the implant sites, indicated in red in the figure below. Numbers on the right represent standard antero-posterior coordinates (Paxinos and Watson, 1997) in millimeters from Bregma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457200" y="1523880"/>
            <a:ext cx="5694480" cy="7391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03-27T01:46:11Z</dcterms:created>
  <dc:creator>Sidarta Ribeiro</dc:creator>
  <dc:description/>
  <dc:language>en-US</dc:language>
  <cp:lastModifiedBy>Liana Holmberg</cp:lastModifiedBy>
  <dcterms:modified xsi:type="dcterms:W3CDTF">2003-12-05T00:12:47Z</dcterms:modified>
  <cp:revision>86</cp:revision>
  <dc:subject/>
  <dc:title>Supplementary Material</dc:title>
</cp:coreProperties>
</file>